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62"/>
  </p:normalViewPr>
  <p:slideViewPr>
    <p:cSldViewPr snapToGrid="0" snapToObjects="1">
      <p:cViewPr varScale="1">
        <p:scale>
          <a:sx n="109" d="100"/>
          <a:sy n="109" d="100"/>
        </p:scale>
        <p:origin x="6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kihirotojo/Desktop/&#22519;&#31558;/IntJNephrol2022Revised/G-A-ProgFina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kihirotojo/Desktop/&#22519;&#31558;/IntJNephrol2022Revised/G-A-ProgFina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kihirotojo/Desktop/&#22519;&#31558;/IntJNephrol2022Revised/G-UP-Prog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kihirotojo/Desktop/&#22519;&#31558;/IntJNephrol2022Revised/G-UP-Prog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CRG1-5'!$AE$2</c:f>
              <c:strCache>
                <c:ptCount val="1"/>
                <c:pt idx="0">
                  <c:v>CR</c:v>
                </c:pt>
              </c:strCache>
            </c:strRef>
          </c:tx>
          <c:spPr>
            <a:solidFill>
              <a:srgbClr val="92D050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CRG1-5'!$AK$2:$AO$2</c:f>
                <c:numCache>
                  <c:formatCode>General</c:formatCode>
                  <c:ptCount val="5"/>
                  <c:pt idx="0">
                    <c:v>2.28785982</c:v>
                  </c:pt>
                  <c:pt idx="1">
                    <c:v>1.7471258449089231</c:v>
                  </c:pt>
                  <c:pt idx="2">
                    <c:v>0.97131376645265033</c:v>
                  </c:pt>
                  <c:pt idx="3">
                    <c:v>3.6948293987292957</c:v>
                  </c:pt>
                  <c:pt idx="4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CRG1-5'!$AF$1:$AJ$1</c:f>
              <c:strCache>
                <c:ptCount val="5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</c:strCache>
            </c:strRef>
          </c:cat>
          <c:val>
            <c:numRef>
              <c:f>'FigCRG1-5'!$AF$2:$AJ$2</c:f>
              <c:numCache>
                <c:formatCode>0.000</c:formatCode>
                <c:ptCount val="5"/>
                <c:pt idx="0">
                  <c:v>1.1123076923076922</c:v>
                </c:pt>
                <c:pt idx="1">
                  <c:v>1.4288888888888889</c:v>
                </c:pt>
                <c:pt idx="2">
                  <c:v>0.9686363636363633</c:v>
                </c:pt>
                <c:pt idx="3">
                  <c:v>3.4474999999999998</c:v>
                </c:pt>
                <c:pt idx="4">
                  <c:v>0.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C2-A644-B236-2AA92FB65536}"/>
            </c:ext>
          </c:extLst>
        </c:ser>
        <c:ser>
          <c:idx val="1"/>
          <c:order val="1"/>
          <c:tx>
            <c:strRef>
              <c:f>'FigCRG1-5'!$AE$3</c:f>
              <c:strCache>
                <c:ptCount val="1"/>
                <c:pt idx="0">
                  <c:v>Non-CR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CRG1-5'!$AK$3:$AO$3</c:f>
                <c:numCache>
                  <c:formatCode>General</c:formatCode>
                  <c:ptCount val="5"/>
                  <c:pt idx="0">
                    <c:v>0.62716291999999996</c:v>
                  </c:pt>
                  <c:pt idx="1">
                    <c:v>1.1357936752453208</c:v>
                  </c:pt>
                  <c:pt idx="2">
                    <c:v>1.0561468429371719</c:v>
                  </c:pt>
                  <c:pt idx="3">
                    <c:v>1.8881421960172788</c:v>
                  </c:pt>
                  <c:pt idx="4">
                    <c:v>0.809651600557742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CRG1-5'!$AF$1:$AJ$1</c:f>
              <c:strCache>
                <c:ptCount val="5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</c:strCache>
            </c:strRef>
          </c:cat>
          <c:val>
            <c:numRef>
              <c:f>'FigCRG1-5'!$AF$3:$AJ$3</c:f>
              <c:numCache>
                <c:formatCode>0.000</c:formatCode>
                <c:ptCount val="5"/>
                <c:pt idx="0">
                  <c:v>1.7</c:v>
                </c:pt>
                <c:pt idx="1">
                  <c:v>1.4354545454545453</c:v>
                </c:pt>
                <c:pt idx="2">
                  <c:v>1.3699999999999999</c:v>
                </c:pt>
                <c:pt idx="3">
                  <c:v>1.8814285714285715</c:v>
                </c:pt>
                <c:pt idx="4">
                  <c:v>0.912499999999999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0C2-A644-B236-2AA92FB655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6602224"/>
        <c:axId val="1686564704"/>
      </c:barChart>
      <c:catAx>
        <c:axId val="1686602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6564704"/>
        <c:crosses val="autoZero"/>
        <c:auto val="1"/>
        <c:lblAlgn val="ctr"/>
        <c:lblOffset val="100"/>
        <c:noMultiLvlLbl val="0"/>
      </c:catAx>
      <c:valAx>
        <c:axId val="16865647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66022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9814282589676291"/>
          <c:y val="0.35059316380310368"/>
          <c:w val="0.20463495188101488"/>
          <c:h val="0.142915484958091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UpodS-E'!$W$2</c:f>
              <c:strCache>
                <c:ptCount val="1"/>
                <c:pt idx="0">
                  <c:v>Surviv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UpodS-E'!$AC$2:$AG$2</c:f>
                <c:numCache>
                  <c:formatCode>General</c:formatCode>
                  <c:ptCount val="5"/>
                  <c:pt idx="0">
                    <c:v>1.7989999999999999</c:v>
                  </c:pt>
                  <c:pt idx="1">
                    <c:v>1.5214722609726055</c:v>
                  </c:pt>
                  <c:pt idx="2">
                    <c:v>0.99578757936911733</c:v>
                  </c:pt>
                  <c:pt idx="3">
                    <c:v>3.6422352721615585</c:v>
                  </c:pt>
                  <c:pt idx="4">
                    <c:v>0.777045687202496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UpodS-E'!$X$1:$AB$1</c:f>
              <c:strCache>
                <c:ptCount val="5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</c:strCache>
            </c:strRef>
          </c:cat>
          <c:val>
            <c:numRef>
              <c:f>'FigUpodS-E'!$X$2:$AB$2</c:f>
              <c:numCache>
                <c:formatCode>0.000</c:formatCode>
                <c:ptCount val="5"/>
                <c:pt idx="0">
                  <c:v>1.41</c:v>
                </c:pt>
                <c:pt idx="1">
                  <c:v>1.208181818181818</c:v>
                </c:pt>
                <c:pt idx="2">
                  <c:v>1.1206451612903225</c:v>
                </c:pt>
                <c:pt idx="3">
                  <c:v>3.0644444444444443</c:v>
                </c:pt>
                <c:pt idx="4">
                  <c:v>1.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19-D342-A9E5-74D5219B965A}"/>
            </c:ext>
          </c:extLst>
        </c:ser>
        <c:ser>
          <c:idx val="1"/>
          <c:order val="1"/>
          <c:tx>
            <c:strRef>
              <c:f>'FigUpodS-E'!$W$3</c:f>
              <c:strCache>
                <c:ptCount val="1"/>
                <c:pt idx="0">
                  <c:v>Renal endpoin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FigUpodS-E'!$AC$3:$AG$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2000000000000013</c:v>
                  </c:pt>
                  <c:pt idx="2">
                    <c:v>1.2186057606953942</c:v>
                  </c:pt>
                  <c:pt idx="3">
                    <c:v>1.8579962325042532</c:v>
                  </c:pt>
                  <c:pt idx="4">
                    <c:v>0.378593889720018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UpodS-E'!$X$1:$AB$1</c:f>
              <c:strCache>
                <c:ptCount val="5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</c:strCache>
            </c:strRef>
          </c:cat>
          <c:val>
            <c:numRef>
              <c:f>'FigUpodS-E'!$X$3:$AB$3</c:f>
              <c:numCache>
                <c:formatCode>0.000</c:formatCode>
                <c:ptCount val="5"/>
                <c:pt idx="0">
                  <c:v>0.1</c:v>
                </c:pt>
                <c:pt idx="1">
                  <c:v>2.9</c:v>
                </c:pt>
                <c:pt idx="2">
                  <c:v>1.1500000000000001</c:v>
                </c:pt>
                <c:pt idx="3">
                  <c:v>2.1950000000000003</c:v>
                </c:pt>
                <c:pt idx="4">
                  <c:v>0.36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619-D342-A9E5-74D5219B96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81489040"/>
        <c:axId val="1681490848"/>
      </c:barChart>
      <c:catAx>
        <c:axId val="1681489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1490848"/>
        <c:crosses val="autoZero"/>
        <c:auto val="1"/>
        <c:lblAlgn val="ctr"/>
        <c:lblOffset val="100"/>
        <c:noMultiLvlLbl val="0"/>
      </c:catAx>
      <c:valAx>
        <c:axId val="16814908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14890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0284833145856764"/>
          <c:y val="0.36858141619953078"/>
          <c:w val="0.2995326209223847"/>
          <c:h val="0.142915484958091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R!$AT$5</c:f>
              <c:strCache>
                <c:ptCount val="1"/>
                <c:pt idx="0">
                  <c:v>CR</c:v>
                </c:pt>
              </c:strCache>
            </c:strRef>
          </c:tx>
          <c:spPr>
            <a:solidFill>
              <a:srgbClr val="92D050"/>
            </a:solidFill>
            <a:ln>
              <a:solidFill>
                <a:srgbClr val="92D05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R!$AX$5:$AZ$5</c:f>
                <c:numCache>
                  <c:formatCode>General</c:formatCode>
                  <c:ptCount val="3"/>
                  <c:pt idx="0">
                    <c:v>0.46855853577677503</c:v>
                  </c:pt>
                  <c:pt idx="1">
                    <c:v>1.6683891432556532</c:v>
                  </c:pt>
                  <c:pt idx="2">
                    <c:v>2.69606930065104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R!$AU$4:$AW$4</c:f>
              <c:strCache>
                <c:ptCount val="3"/>
                <c:pt idx="0">
                  <c:v>UP1</c:v>
                </c:pt>
                <c:pt idx="1">
                  <c:v>UP2</c:v>
                </c:pt>
                <c:pt idx="2">
                  <c:v>UP3</c:v>
                </c:pt>
              </c:strCache>
            </c:strRef>
          </c:cat>
          <c:val>
            <c:numRef>
              <c:f>CR!$AU$5:$AW$5</c:f>
              <c:numCache>
                <c:formatCode>0.000</c:formatCode>
                <c:ptCount val="3"/>
                <c:pt idx="0">
                  <c:v>0.47083333333333338</c:v>
                </c:pt>
                <c:pt idx="1">
                  <c:v>1.1783999999999999</c:v>
                </c:pt>
                <c:pt idx="2">
                  <c:v>2.59625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4D-4F47-A3BE-77D43FB1DD4E}"/>
            </c:ext>
          </c:extLst>
        </c:ser>
        <c:ser>
          <c:idx val="1"/>
          <c:order val="1"/>
          <c:tx>
            <c:strRef>
              <c:f>CR!$AT$6</c:f>
              <c:strCache>
                <c:ptCount val="1"/>
                <c:pt idx="0">
                  <c:v>Non-CR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rgbClr val="FFC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R!$AX$6:$AZ$6</c:f>
                <c:numCache>
                  <c:formatCode>General</c:formatCode>
                  <c:ptCount val="3"/>
                  <c:pt idx="0">
                    <c:v>0.38622100754188227</c:v>
                  </c:pt>
                  <c:pt idx="1">
                    <c:v>0.7858907318605064</c:v>
                  </c:pt>
                  <c:pt idx="2">
                    <c:v>1.38759246796127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R!$AU$4:$AW$4</c:f>
              <c:strCache>
                <c:ptCount val="3"/>
                <c:pt idx="0">
                  <c:v>UP1</c:v>
                </c:pt>
                <c:pt idx="1">
                  <c:v>UP2</c:v>
                </c:pt>
                <c:pt idx="2">
                  <c:v>UP3</c:v>
                </c:pt>
              </c:strCache>
            </c:strRef>
          </c:cat>
          <c:val>
            <c:numRef>
              <c:f>CR!$AU$6:$AW$6</c:f>
              <c:numCache>
                <c:formatCode>0.000</c:formatCode>
                <c:ptCount val="3"/>
                <c:pt idx="0">
                  <c:v>0.47499999999999998</c:v>
                </c:pt>
                <c:pt idx="1">
                  <c:v>1.2263636363636365</c:v>
                </c:pt>
                <c:pt idx="2">
                  <c:v>1.83142857142857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04D-4F47-A3BE-77D43FB1DD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39201743"/>
        <c:axId val="1339384607"/>
      </c:barChart>
      <c:catAx>
        <c:axId val="13392017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39384607"/>
        <c:crosses val="autoZero"/>
        <c:auto val="1"/>
        <c:lblAlgn val="ctr"/>
        <c:lblOffset val="100"/>
        <c:noMultiLvlLbl val="0"/>
      </c:catAx>
      <c:valAx>
        <c:axId val="133938460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[Red]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3920174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5664676290463684"/>
          <c:y val="0.2145242782152231"/>
          <c:w val="0.20724212598425193"/>
          <c:h val="0.1562058909303003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Endpoint!$AT$2</c:f>
              <c:strCache>
                <c:ptCount val="1"/>
                <c:pt idx="0">
                  <c:v>Surviva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Endpoint!$AX$2:$AZ$2</c:f>
                <c:numCache>
                  <c:formatCode>General</c:formatCode>
                  <c:ptCount val="3"/>
                  <c:pt idx="0">
                    <c:v>0.45379061903693646</c:v>
                  </c:pt>
                  <c:pt idx="1">
                    <c:v>1.3947888641689663</c:v>
                  </c:pt>
                  <c:pt idx="2">
                    <c:v>2.33324619139543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ndpoint!$AU$1:$AW$1</c:f>
              <c:strCache>
                <c:ptCount val="3"/>
                <c:pt idx="0">
                  <c:v>UP1</c:v>
                </c:pt>
                <c:pt idx="1">
                  <c:v>UP2</c:v>
                </c:pt>
                <c:pt idx="2">
                  <c:v>UP3</c:v>
                </c:pt>
              </c:strCache>
            </c:strRef>
          </c:cat>
          <c:val>
            <c:numRef>
              <c:f>Endpoint!$AU$2:$AW$2</c:f>
              <c:numCache>
                <c:formatCode>0.000</c:formatCode>
                <c:ptCount val="3"/>
                <c:pt idx="0">
                  <c:v>0.48518518518518511</c:v>
                </c:pt>
                <c:pt idx="1">
                  <c:v>1.2387804878048783</c:v>
                </c:pt>
                <c:pt idx="2">
                  <c:v>2.28529411764705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11-1549-881C-CE58D650308C}"/>
            </c:ext>
          </c:extLst>
        </c:ser>
        <c:ser>
          <c:idx val="1"/>
          <c:order val="1"/>
          <c:tx>
            <c:strRef>
              <c:f>Endpoint!$AT$3</c:f>
              <c:strCache>
                <c:ptCount val="1"/>
                <c:pt idx="0">
                  <c:v>Renal endpoin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Endpoint!$AX$3:$AZ$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55173967291347337</c:v>
                  </c:pt>
                  <c:pt idx="2">
                    <c:v>1.79707590774063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ndpoint!$AU$1:$AW$1</c:f>
              <c:strCache>
                <c:ptCount val="3"/>
                <c:pt idx="0">
                  <c:v>UP1</c:v>
                </c:pt>
                <c:pt idx="1">
                  <c:v>UP2</c:v>
                </c:pt>
                <c:pt idx="2">
                  <c:v>UP3</c:v>
                </c:pt>
              </c:strCache>
            </c:strRef>
          </c:cat>
          <c:val>
            <c:numRef>
              <c:f>Endpoint!$AU$3:$AW$3</c:f>
              <c:numCache>
                <c:formatCode>0.000</c:formatCode>
                <c:ptCount val="3"/>
                <c:pt idx="0">
                  <c:v>0.1</c:v>
                </c:pt>
                <c:pt idx="1">
                  <c:v>0.94166666666666676</c:v>
                </c:pt>
                <c:pt idx="2">
                  <c:v>2.09727272727272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B11-1549-881C-CE58D65030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34217679"/>
        <c:axId val="1396557343"/>
      </c:barChart>
      <c:catAx>
        <c:axId val="14342176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396557343"/>
        <c:crosses val="autoZero"/>
        <c:auto val="1"/>
        <c:lblAlgn val="ctr"/>
        <c:lblOffset val="100"/>
        <c:noMultiLvlLbl val="0"/>
      </c:catAx>
      <c:valAx>
        <c:axId val="139655734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342176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3873053368328958"/>
          <c:y val="0.21798993875765529"/>
          <c:w val="0.3001583552055993"/>
          <c:h val="0.3093904928550597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E2BD5A-0E6E-1043-9612-B0F15048A7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D033F9E-5959-7F49-AF2A-100277AA19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013975-A878-494F-AAC2-4D5A5B6599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2CC02-0080-9046-862D-2DEEA34E4B48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026883-8B6A-C147-942B-589DEC7D9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4E09748-BCCB-AE47-81B3-818599C9F0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37598-A8F0-8442-BC82-2103FCA2A9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269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8DDC9F-53D7-6440-8D1F-20F9BFFC04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668B6CC-5801-6447-AB8F-A04FF57504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5BA0C3-1D3D-BC4A-BD34-08D7CAF2D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2CC02-0080-9046-862D-2DEEA34E4B48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5E8421E-DAFC-0D48-B02F-F4FE39752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A28E76A-46E4-CE4C-8367-CD929F1EF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37598-A8F0-8442-BC82-2103FCA2A9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1067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C1D94F5-BDB7-CD46-AF2E-5AB89478C0E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76925AB-6447-A848-8EBF-33B9D7BAD7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0F776C-F9EE-C54A-ACB2-15ED59117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2CC02-0080-9046-862D-2DEEA34E4B48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D96292-5A71-DB45-B305-BCB273C98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2AB4CD-CF25-8949-884A-32E585DEE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37598-A8F0-8442-BC82-2103FCA2A9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4765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F2A159-AAD4-8346-B6C0-165187FBF6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7E51EF1-C726-674B-8544-EB40E9DF35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A85B989-E6A5-1540-B7C5-8C491312B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2CC02-0080-9046-862D-2DEEA34E4B48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8E175B0-F2AC-714E-9627-294F5848E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727AA8-6E59-244B-9AE5-87E5ACF947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37598-A8F0-8442-BC82-2103FCA2A9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9635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DC0FBC-58D6-C84B-A7EF-DB5E7C982F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DB1BF28-8E1D-D34C-AD3F-AF7BB93E1E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E0CC70-7724-254A-97BF-1FC561E33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2CC02-0080-9046-862D-2DEEA34E4B48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6C59A4-9770-994A-BB54-595911C0F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EF15B9C-25B8-0443-B22A-3670A2F5A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37598-A8F0-8442-BC82-2103FCA2A9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5872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4918A4-3761-7340-9009-F78D9C79AD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93D0E6B-3F92-ED49-8444-061B7DEA6B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C31F90A-832D-864F-BEF4-32D0C9581A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CB299C7-9F60-624D-A2DE-B94F5DEE5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2CC02-0080-9046-862D-2DEEA34E4B48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ACD63D1-BF37-9A4D-A30A-6E39A0622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6768F4C-7188-C743-9900-C269E09A6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37598-A8F0-8442-BC82-2103FCA2A9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7088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E1DD76-1BDA-764D-9862-1F5E1BFB82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904436A-BE6A-0C48-9CC9-8A76B6F21D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251D0CB-2B2A-594E-8357-B4BBF4B8A6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C6EE250-1B9B-6940-8637-D2B7B3898A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99AF3AE-99A3-5149-8363-24F94D9D00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E809C97-85A3-E94C-96F0-26CC9EFB7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2CC02-0080-9046-862D-2DEEA34E4B48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B8F5F85-F0FC-7A41-8246-F0AEF2573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04E696A-4D71-3846-9210-96C6CDBAC8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37598-A8F0-8442-BC82-2103FCA2A9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896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BA6E47-847E-0D49-8766-67B99F8F71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C5124D2-9AA2-F842-9739-825FD4574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2CC02-0080-9046-862D-2DEEA34E4B48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A617D77-F636-444A-A6BD-6DB7BA2DCB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CDF521C-035B-F045-A415-CFE03B0A3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37598-A8F0-8442-BC82-2103FCA2A9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905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901EBCE-30FB-B14A-8899-025ED69CC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2CC02-0080-9046-862D-2DEEA34E4B48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C3F4BA0-D6FC-B342-BF12-9EB424AFD3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0E285C6-648A-5B44-BDE7-CCCDC1A8C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37598-A8F0-8442-BC82-2103FCA2A9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1138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F8C5E9-055D-8542-B96D-7951456D13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48C47D4-8DC0-5D4D-BAF6-D3D29E9F46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0DEC13C-FAF8-E742-9A68-CC305788B7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8820EFC-B317-B64E-930C-1F4CA234E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2CC02-0080-9046-862D-2DEEA34E4B48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615EE9E-0732-314F-8050-C4BFB091B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9D3519E-8492-1C40-B244-BCE166B61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37598-A8F0-8442-BC82-2103FCA2A9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567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034283-3DD4-FE40-98EC-550D7D6512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B8A4553-AA77-7B4C-A696-567028D918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3665042-A4E9-764D-840E-7079A65C1A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E53F33F-F135-FC45-A94F-0D1C78A61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2CC02-0080-9046-862D-2DEEA34E4B48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021FBF2-FFC4-AB4F-8141-3AD24F739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F07FB03-F78C-A048-9B0F-06D3799746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537598-A8F0-8442-BC82-2103FCA2A9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4899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7FC7F1D-C285-8F4A-BE31-6E298BF63D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955E103-CE61-0E4B-89DC-540DB3EBBB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EC5CD7-1038-C045-90CC-4322372342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2CC02-0080-9046-862D-2DEEA34E4B48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BF23E0-7DBB-5D4C-9DA7-DD684F42C5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901C1D-790E-214D-A017-8E3EA50DB78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537598-A8F0-8442-BC82-2103FCA2A9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6771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グループ化 58">
            <a:extLst>
              <a:ext uri="{FF2B5EF4-FFF2-40B4-BE49-F238E27FC236}">
                <a16:creationId xmlns:a16="http://schemas.microsoft.com/office/drawing/2014/main" id="{9C983E03-9757-484A-8A52-1821020BF942}"/>
              </a:ext>
            </a:extLst>
          </p:cNvPr>
          <p:cNvGrpSpPr/>
          <p:nvPr/>
        </p:nvGrpSpPr>
        <p:grpSpPr>
          <a:xfrm>
            <a:off x="901040" y="133856"/>
            <a:ext cx="10803268" cy="6508573"/>
            <a:chOff x="901040" y="133856"/>
            <a:chExt cx="10803268" cy="6508573"/>
          </a:xfrm>
        </p:grpSpPr>
        <p:grpSp>
          <p:nvGrpSpPr>
            <p:cNvPr id="54" name="グループ化 53">
              <a:extLst>
                <a:ext uri="{FF2B5EF4-FFF2-40B4-BE49-F238E27FC236}">
                  <a16:creationId xmlns:a16="http://schemas.microsoft.com/office/drawing/2014/main" id="{FB59DF47-EC5B-4D4A-9765-22DCC9512779}"/>
                </a:ext>
              </a:extLst>
            </p:cNvPr>
            <p:cNvGrpSpPr/>
            <p:nvPr/>
          </p:nvGrpSpPr>
          <p:grpSpPr>
            <a:xfrm>
              <a:off x="929071" y="196496"/>
              <a:ext cx="10775237" cy="6445933"/>
              <a:chOff x="929071" y="196496"/>
              <a:chExt cx="10775237" cy="6445933"/>
            </a:xfrm>
          </p:grpSpPr>
          <p:grpSp>
            <p:nvGrpSpPr>
              <p:cNvPr id="29" name="グループ化 28">
                <a:extLst>
                  <a:ext uri="{FF2B5EF4-FFF2-40B4-BE49-F238E27FC236}">
                    <a16:creationId xmlns:a16="http://schemas.microsoft.com/office/drawing/2014/main" id="{59FE8F5E-1F6A-6847-BCD4-2F8E8C0DFDEC}"/>
                  </a:ext>
                </a:extLst>
              </p:cNvPr>
              <p:cNvGrpSpPr/>
              <p:nvPr/>
            </p:nvGrpSpPr>
            <p:grpSpPr>
              <a:xfrm>
                <a:off x="929071" y="196496"/>
                <a:ext cx="10775237" cy="3692769"/>
                <a:chOff x="909800" y="1222443"/>
                <a:chExt cx="10775237" cy="4543875"/>
              </a:xfrm>
            </p:grpSpPr>
            <p:graphicFrame>
              <p:nvGraphicFramePr>
                <p:cNvPr id="4" name="グラフ 3">
                  <a:extLst>
                    <a:ext uri="{FF2B5EF4-FFF2-40B4-BE49-F238E27FC236}">
                      <a16:creationId xmlns:a16="http://schemas.microsoft.com/office/drawing/2014/main" id="{2CBB2029-FAA6-214C-8B33-FE5E321FAE45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964446135"/>
                    </p:ext>
                  </p:extLst>
                </p:nvPr>
              </p:nvGraphicFramePr>
              <p:xfrm>
                <a:off x="7113037" y="1530220"/>
                <a:ext cx="4572000" cy="423609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5" name="グラフ 4">
                  <a:extLst>
                    <a:ext uri="{FF2B5EF4-FFF2-40B4-BE49-F238E27FC236}">
                      <a16:creationId xmlns:a16="http://schemas.microsoft.com/office/drawing/2014/main" id="{10E1B4DF-3BCA-C649-8041-BE38BCFC650D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533270630"/>
                    </p:ext>
                  </p:extLst>
                </p:nvPr>
              </p:nvGraphicFramePr>
              <p:xfrm>
                <a:off x="1421363" y="1530220"/>
                <a:ext cx="5334000" cy="423609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6" name="テキスト ボックス 5">
                  <a:extLst>
                    <a:ext uri="{FF2B5EF4-FFF2-40B4-BE49-F238E27FC236}">
                      <a16:creationId xmlns:a16="http://schemas.microsoft.com/office/drawing/2014/main" id="{744BB16E-18B1-B94C-9A78-107450BA482E}"/>
                    </a:ext>
                  </a:extLst>
                </p:cNvPr>
                <p:cNvSpPr txBox="1"/>
                <p:nvPr/>
              </p:nvSpPr>
              <p:spPr>
                <a:xfrm rot="16200000">
                  <a:off x="28052" y="3275111"/>
                  <a:ext cx="207127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Urinary podocytes ( /HPF)</a:t>
                  </a:r>
                  <a:endParaRPr kumimoji="1" lang="ja-JP" altLang="en-US" sz="140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7" name="テキスト ボックス 6">
                  <a:extLst>
                    <a:ext uri="{FF2B5EF4-FFF2-40B4-BE49-F238E27FC236}">
                      <a16:creationId xmlns:a16="http://schemas.microsoft.com/office/drawing/2014/main" id="{D49530B1-BE73-064E-B8EB-E8F39DB1FD92}"/>
                    </a:ext>
                  </a:extLst>
                </p:cNvPr>
                <p:cNvSpPr txBox="1"/>
                <p:nvPr/>
              </p:nvSpPr>
              <p:spPr>
                <a:xfrm rot="16200000">
                  <a:off x="5772734" y="3457061"/>
                  <a:ext cx="2071273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Urinary podocytes ( /HPF)</a:t>
                  </a:r>
                  <a:endParaRPr kumimoji="1" lang="ja-JP" altLang="en-US" sz="140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8" name="テキスト ボックス 7">
                  <a:extLst>
                    <a:ext uri="{FF2B5EF4-FFF2-40B4-BE49-F238E27FC236}">
                      <a16:creationId xmlns:a16="http://schemas.microsoft.com/office/drawing/2014/main" id="{1E89931F-431B-C440-823A-BB0D64004D24}"/>
                    </a:ext>
                  </a:extLst>
                </p:cNvPr>
                <p:cNvSpPr txBox="1"/>
                <p:nvPr/>
              </p:nvSpPr>
              <p:spPr>
                <a:xfrm>
                  <a:off x="2351314" y="1222443"/>
                  <a:ext cx="13376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Renal prognosis</a:t>
                  </a:r>
                  <a:endParaRPr kumimoji="1" lang="ja-JP" altLang="en-US" sz="140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9" name="テキスト ボックス 8">
                  <a:extLst>
                    <a:ext uri="{FF2B5EF4-FFF2-40B4-BE49-F238E27FC236}">
                      <a16:creationId xmlns:a16="http://schemas.microsoft.com/office/drawing/2014/main" id="{A2115EF9-EADC-5F4E-9580-51A87A14BA1E}"/>
                    </a:ext>
                  </a:extLst>
                </p:cNvPr>
                <p:cNvSpPr txBox="1"/>
                <p:nvPr/>
              </p:nvSpPr>
              <p:spPr>
                <a:xfrm>
                  <a:off x="7753519" y="1222443"/>
                  <a:ext cx="186044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Response to treatment</a:t>
                  </a:r>
                  <a:endParaRPr kumimoji="1" lang="ja-JP" altLang="en-US" sz="140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grpSp>
              <p:nvGrpSpPr>
                <p:cNvPr id="17" name="グループ化 16">
                  <a:extLst>
                    <a:ext uri="{FF2B5EF4-FFF2-40B4-BE49-F238E27FC236}">
                      <a16:creationId xmlns:a16="http://schemas.microsoft.com/office/drawing/2014/main" id="{08A99A4A-521C-904A-ABA8-C2CD3015B27D}"/>
                    </a:ext>
                  </a:extLst>
                </p:cNvPr>
                <p:cNvGrpSpPr/>
                <p:nvPr/>
              </p:nvGrpSpPr>
              <p:grpSpPr>
                <a:xfrm>
                  <a:off x="7685314" y="3284376"/>
                  <a:ext cx="211430" cy="220186"/>
                  <a:chOff x="7685314" y="3284376"/>
                  <a:chExt cx="211430" cy="220186"/>
                </a:xfrm>
              </p:grpSpPr>
              <p:cxnSp>
                <p:nvCxnSpPr>
                  <p:cNvPr id="11" name="直線コネクタ 10">
                    <a:extLst>
                      <a:ext uri="{FF2B5EF4-FFF2-40B4-BE49-F238E27FC236}">
                        <a16:creationId xmlns:a16="http://schemas.microsoft.com/office/drawing/2014/main" id="{07207AD5-F829-1A43-B9C0-67BE4989DE8F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7685314" y="3284376"/>
                    <a:ext cx="0" cy="14462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" name="直線コネクタ 12">
                    <a:extLst>
                      <a:ext uri="{FF2B5EF4-FFF2-40B4-BE49-F238E27FC236}">
                        <a16:creationId xmlns:a16="http://schemas.microsoft.com/office/drawing/2014/main" id="{DE80EA7D-183C-5A4F-B60F-7A8BD9E0A6D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688203" y="3284376"/>
                    <a:ext cx="20854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" name="直線コネクタ 14">
                    <a:extLst>
                      <a:ext uri="{FF2B5EF4-FFF2-40B4-BE49-F238E27FC236}">
                        <a16:creationId xmlns:a16="http://schemas.microsoft.com/office/drawing/2014/main" id="{F0EC96AD-005B-1D4C-8942-D639EA21EA3F}"/>
                      </a:ext>
                    </a:extLst>
                  </p:cNvPr>
                  <p:cNvCxnSpPr/>
                  <p:nvPr/>
                </p:nvCxnSpPr>
                <p:spPr>
                  <a:xfrm>
                    <a:off x="7896744" y="3284376"/>
                    <a:ext cx="0" cy="22018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8" name="グループ化 17">
                  <a:extLst>
                    <a:ext uri="{FF2B5EF4-FFF2-40B4-BE49-F238E27FC236}">
                      <a16:creationId xmlns:a16="http://schemas.microsoft.com/office/drawing/2014/main" id="{18118AAF-8528-964C-AED3-D2309D1A60A7}"/>
                    </a:ext>
                  </a:extLst>
                </p:cNvPr>
                <p:cNvGrpSpPr/>
                <p:nvPr/>
              </p:nvGrpSpPr>
              <p:grpSpPr>
                <a:xfrm>
                  <a:off x="9540258" y="1875792"/>
                  <a:ext cx="211430" cy="220186"/>
                  <a:chOff x="7685314" y="3284376"/>
                  <a:chExt cx="211430" cy="220186"/>
                </a:xfrm>
              </p:grpSpPr>
              <p:cxnSp>
                <p:nvCxnSpPr>
                  <p:cNvPr id="19" name="直線コネクタ 18">
                    <a:extLst>
                      <a:ext uri="{FF2B5EF4-FFF2-40B4-BE49-F238E27FC236}">
                        <a16:creationId xmlns:a16="http://schemas.microsoft.com/office/drawing/2014/main" id="{5ED86C9E-7E58-4E48-83B5-2D5BCDCA7BF6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7685314" y="3284376"/>
                    <a:ext cx="0" cy="14462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直線コネクタ 19">
                    <a:extLst>
                      <a:ext uri="{FF2B5EF4-FFF2-40B4-BE49-F238E27FC236}">
                        <a16:creationId xmlns:a16="http://schemas.microsoft.com/office/drawing/2014/main" id="{E5C0FE1D-891C-404A-A003-59C3E587801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688203" y="3284376"/>
                    <a:ext cx="20854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直線コネクタ 20">
                    <a:extLst>
                      <a:ext uri="{FF2B5EF4-FFF2-40B4-BE49-F238E27FC236}">
                        <a16:creationId xmlns:a16="http://schemas.microsoft.com/office/drawing/2014/main" id="{CE9E8757-5A44-024E-BDD3-4A4A8B248F14}"/>
                      </a:ext>
                    </a:extLst>
                  </p:cNvPr>
                  <p:cNvCxnSpPr/>
                  <p:nvPr/>
                </p:nvCxnSpPr>
                <p:spPr>
                  <a:xfrm>
                    <a:off x="7896744" y="3284376"/>
                    <a:ext cx="0" cy="22018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2" name="グループ化 21">
                  <a:extLst>
                    <a:ext uri="{FF2B5EF4-FFF2-40B4-BE49-F238E27FC236}">
                      <a16:creationId xmlns:a16="http://schemas.microsoft.com/office/drawing/2014/main" id="{FD6BF2DD-8A5E-FD4B-84D0-26D27CEA274E}"/>
                    </a:ext>
                  </a:extLst>
                </p:cNvPr>
                <p:cNvGrpSpPr/>
                <p:nvPr/>
              </p:nvGrpSpPr>
              <p:grpSpPr>
                <a:xfrm flipH="1">
                  <a:off x="2643880" y="3246651"/>
                  <a:ext cx="211430" cy="220186"/>
                  <a:chOff x="7685314" y="3284376"/>
                  <a:chExt cx="211430" cy="220186"/>
                </a:xfrm>
              </p:grpSpPr>
              <p:cxnSp>
                <p:nvCxnSpPr>
                  <p:cNvPr id="23" name="直線コネクタ 22">
                    <a:extLst>
                      <a:ext uri="{FF2B5EF4-FFF2-40B4-BE49-F238E27FC236}">
                        <a16:creationId xmlns:a16="http://schemas.microsoft.com/office/drawing/2014/main" id="{56EF0F8C-CC4F-5E4C-89CC-BDFC4149BCBC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7685314" y="3284376"/>
                    <a:ext cx="0" cy="144623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" name="直線コネクタ 23">
                    <a:extLst>
                      <a:ext uri="{FF2B5EF4-FFF2-40B4-BE49-F238E27FC236}">
                        <a16:creationId xmlns:a16="http://schemas.microsoft.com/office/drawing/2014/main" id="{46C328D5-83D1-7B42-84FE-31468F3E3B9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688203" y="3284376"/>
                    <a:ext cx="208541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" name="直線コネクタ 24">
                    <a:extLst>
                      <a:ext uri="{FF2B5EF4-FFF2-40B4-BE49-F238E27FC236}">
                        <a16:creationId xmlns:a16="http://schemas.microsoft.com/office/drawing/2014/main" id="{F6873B72-0741-5344-877F-F3575B816B5A}"/>
                      </a:ext>
                    </a:extLst>
                  </p:cNvPr>
                  <p:cNvCxnSpPr/>
                  <p:nvPr/>
                </p:nvCxnSpPr>
                <p:spPr>
                  <a:xfrm>
                    <a:off x="7896744" y="3284376"/>
                    <a:ext cx="0" cy="22018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95F788AC-3813-0A4F-8C7F-2798E7CE0CA9}"/>
                    </a:ext>
                  </a:extLst>
                </p:cNvPr>
                <p:cNvSpPr txBox="1"/>
                <p:nvPr/>
              </p:nvSpPr>
              <p:spPr>
                <a:xfrm>
                  <a:off x="2610176" y="3012838"/>
                  <a:ext cx="2744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*</a:t>
                  </a:r>
                  <a:endParaRPr kumimoji="1" lang="ja-JP" altLang="en-US" sz="140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id="{071C2FBD-7C1A-EE43-AFC6-5B0FB289F7CA}"/>
                    </a:ext>
                  </a:extLst>
                </p:cNvPr>
                <p:cNvSpPr txBox="1"/>
                <p:nvPr/>
              </p:nvSpPr>
              <p:spPr>
                <a:xfrm>
                  <a:off x="7617370" y="3031910"/>
                  <a:ext cx="36420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**</a:t>
                  </a:r>
                  <a:endParaRPr kumimoji="1" lang="ja-JP" altLang="en-US" sz="140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5038612C-E710-A643-BA63-0CC7E97FF8AF}"/>
                    </a:ext>
                  </a:extLst>
                </p:cNvPr>
                <p:cNvSpPr txBox="1"/>
                <p:nvPr/>
              </p:nvSpPr>
              <p:spPr>
                <a:xfrm>
                  <a:off x="9465316" y="1645928"/>
                  <a:ext cx="36420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**</a:t>
                  </a:r>
                  <a:endParaRPr kumimoji="1" lang="ja-JP" altLang="en-US" sz="140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graphicFrame>
            <p:nvGraphicFramePr>
              <p:cNvPr id="30" name="グラフ 29">
                <a:extLst>
                  <a:ext uri="{FF2B5EF4-FFF2-40B4-BE49-F238E27FC236}">
                    <a16:creationId xmlns:a16="http://schemas.microsoft.com/office/drawing/2014/main" id="{D4D86FF4-6B46-D84D-800D-0F2CC5686DC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244146413"/>
                  </p:ext>
                </p:extLst>
              </p:nvPr>
            </p:nvGraphicFramePr>
            <p:xfrm>
              <a:off x="7105670" y="3899229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07017E4A-90CD-9A43-B324-5415BA3A2521}"/>
                  </a:ext>
                </a:extLst>
              </p:cNvPr>
              <p:cNvSpPr txBox="1"/>
              <p:nvPr/>
            </p:nvSpPr>
            <p:spPr>
              <a:xfrm rot="16200000">
                <a:off x="5990164" y="5096375"/>
                <a:ext cx="168330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Urinary podocytes ( /HPF)</a:t>
                </a:r>
                <a:endParaRPr kumimoji="1" lang="ja-JP" altLang="en-US" sz="14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48DABDA4-8198-5B49-9FD2-9B4ECF2922FC}"/>
                  </a:ext>
                </a:extLst>
              </p:cNvPr>
              <p:cNvSpPr txBox="1"/>
              <p:nvPr/>
            </p:nvSpPr>
            <p:spPr>
              <a:xfrm rot="16200000">
                <a:off x="241307" y="5116940"/>
                <a:ext cx="168330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Urinary podocytes ( /HPF)</a:t>
                </a:r>
                <a:endParaRPr kumimoji="1" lang="ja-JP" altLang="en-US" sz="14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3" name="直線コネクタ 2">
                <a:extLst>
                  <a:ext uri="{FF2B5EF4-FFF2-40B4-BE49-F238E27FC236}">
                    <a16:creationId xmlns:a16="http://schemas.microsoft.com/office/drawing/2014/main" id="{4ABA34E3-8ACA-E145-BDA4-3015E0BF4A41}"/>
                  </a:ext>
                </a:extLst>
              </p:cNvPr>
              <p:cNvCxnSpPr/>
              <p:nvPr/>
            </p:nvCxnSpPr>
            <p:spPr>
              <a:xfrm>
                <a:off x="9852964" y="4223098"/>
                <a:ext cx="0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4" name="グループ化 43">
                <a:extLst>
                  <a:ext uri="{FF2B5EF4-FFF2-40B4-BE49-F238E27FC236}">
                    <a16:creationId xmlns:a16="http://schemas.microsoft.com/office/drawing/2014/main" id="{82FDCC85-CAD2-8040-BB16-F2E526AB787A}"/>
                  </a:ext>
                </a:extLst>
              </p:cNvPr>
              <p:cNvGrpSpPr/>
              <p:nvPr/>
            </p:nvGrpSpPr>
            <p:grpSpPr>
              <a:xfrm>
                <a:off x="7822917" y="4142735"/>
                <a:ext cx="2058503" cy="674005"/>
                <a:chOff x="7822917" y="4142735"/>
                <a:chExt cx="2058503" cy="674005"/>
              </a:xfrm>
            </p:grpSpPr>
            <p:cxnSp>
              <p:nvCxnSpPr>
                <p:cNvPr id="12" name="直線コネクタ 11">
                  <a:extLst>
                    <a:ext uri="{FF2B5EF4-FFF2-40B4-BE49-F238E27FC236}">
                      <a16:creationId xmlns:a16="http://schemas.microsoft.com/office/drawing/2014/main" id="{4AA3FAFA-A90E-5B44-A86B-FAB1DD7EDEF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881420" y="4144889"/>
                  <a:ext cx="0" cy="13592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線コネクタ 15">
                  <a:extLst>
                    <a:ext uri="{FF2B5EF4-FFF2-40B4-BE49-F238E27FC236}">
                      <a16:creationId xmlns:a16="http://schemas.microsoft.com/office/drawing/2014/main" id="{A9FE96CF-74B0-174A-8A86-E5F5DA6B5F1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822917" y="4144889"/>
                  <a:ext cx="2058503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直線コネクタ 33">
                  <a:extLst>
                    <a:ext uri="{FF2B5EF4-FFF2-40B4-BE49-F238E27FC236}">
                      <a16:creationId xmlns:a16="http://schemas.microsoft.com/office/drawing/2014/main" id="{C5953717-7D13-414F-A879-53001CE6E457}"/>
                    </a:ext>
                  </a:extLst>
                </p:cNvPr>
                <p:cNvCxnSpPr/>
                <p:nvPr/>
              </p:nvCxnSpPr>
              <p:spPr>
                <a:xfrm>
                  <a:off x="7822917" y="4142735"/>
                  <a:ext cx="0" cy="67400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直線コネクタ 37">
                  <a:extLst>
                    <a:ext uri="{FF2B5EF4-FFF2-40B4-BE49-F238E27FC236}">
                      <a16:creationId xmlns:a16="http://schemas.microsoft.com/office/drawing/2014/main" id="{FE507390-88A3-904E-82E5-0F80A2506D4D}"/>
                    </a:ext>
                  </a:extLst>
                </p:cNvPr>
                <p:cNvCxnSpPr/>
                <p:nvPr/>
              </p:nvCxnSpPr>
              <p:spPr>
                <a:xfrm flipH="1">
                  <a:off x="8852168" y="4238252"/>
                  <a:ext cx="1029252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直線コネクタ 39">
                  <a:extLst>
                    <a:ext uri="{FF2B5EF4-FFF2-40B4-BE49-F238E27FC236}">
                      <a16:creationId xmlns:a16="http://schemas.microsoft.com/office/drawing/2014/main" id="{63C63D28-9863-8541-B345-42767089A7C5}"/>
                    </a:ext>
                  </a:extLst>
                </p:cNvPr>
                <p:cNvCxnSpPr/>
                <p:nvPr/>
              </p:nvCxnSpPr>
              <p:spPr>
                <a:xfrm>
                  <a:off x="8852168" y="4238252"/>
                  <a:ext cx="0" cy="3489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id="{F9DCF917-37B5-3747-A5CC-A23009BCD13E}"/>
                    </a:ext>
                  </a:extLst>
                </p:cNvPr>
                <p:cNvCxnSpPr/>
                <p:nvPr/>
              </p:nvCxnSpPr>
              <p:spPr>
                <a:xfrm>
                  <a:off x="9111248" y="4243332"/>
                  <a:ext cx="0" cy="34898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62AF11A2-CB3F-9149-B800-F5B316C0AF4F}"/>
                  </a:ext>
                </a:extLst>
              </p:cNvPr>
              <p:cNvSpPr txBox="1"/>
              <p:nvPr/>
            </p:nvSpPr>
            <p:spPr>
              <a:xfrm>
                <a:off x="8731806" y="3966761"/>
                <a:ext cx="364202" cy="2067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**</a:t>
                </a:r>
                <a:endParaRPr kumimoji="1" lang="ja-JP" altLang="en-US" sz="14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924D6595-FFBD-4347-8581-371DFC325E34}"/>
                  </a:ext>
                </a:extLst>
              </p:cNvPr>
              <p:cNvSpPr txBox="1"/>
              <p:nvPr/>
            </p:nvSpPr>
            <p:spPr>
              <a:xfrm>
                <a:off x="9163606" y="4078521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*</a:t>
                </a:r>
                <a:endParaRPr kumimoji="1" lang="ja-JP" altLang="en-US" sz="14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graphicFrame>
            <p:nvGraphicFramePr>
              <p:cNvPr id="45" name="グラフ 44">
                <a:extLst>
                  <a:ext uri="{FF2B5EF4-FFF2-40B4-BE49-F238E27FC236}">
                    <a16:creationId xmlns:a16="http://schemas.microsoft.com/office/drawing/2014/main" id="{819A6A77-C7D1-6444-B3A8-714F4B872D8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37136046"/>
                  </p:ext>
                </p:extLst>
              </p:nvPr>
            </p:nvGraphicFramePr>
            <p:xfrm>
              <a:off x="1426370" y="3878664"/>
              <a:ext cx="4992478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pSp>
            <p:nvGrpSpPr>
              <p:cNvPr id="53" name="グループ化 52">
                <a:extLst>
                  <a:ext uri="{FF2B5EF4-FFF2-40B4-BE49-F238E27FC236}">
                    <a16:creationId xmlns:a16="http://schemas.microsoft.com/office/drawing/2014/main" id="{B788CD58-7926-5B4C-AB1B-B6DA44B470A0}"/>
                  </a:ext>
                </a:extLst>
              </p:cNvPr>
              <p:cNvGrpSpPr/>
              <p:nvPr/>
            </p:nvGrpSpPr>
            <p:grpSpPr>
              <a:xfrm>
                <a:off x="2095500" y="4076176"/>
                <a:ext cx="1978209" cy="669520"/>
                <a:chOff x="2095500" y="4076176"/>
                <a:chExt cx="1978209" cy="669520"/>
              </a:xfrm>
            </p:grpSpPr>
            <p:cxnSp>
              <p:nvCxnSpPr>
                <p:cNvPr id="47" name="直線コネクタ 46">
                  <a:extLst>
                    <a:ext uri="{FF2B5EF4-FFF2-40B4-BE49-F238E27FC236}">
                      <a16:creationId xmlns:a16="http://schemas.microsoft.com/office/drawing/2014/main" id="{4853BF93-59E8-FD4E-B939-974631FC01A1}"/>
                    </a:ext>
                  </a:extLst>
                </p:cNvPr>
                <p:cNvCxnSpPr/>
                <p:nvPr/>
              </p:nvCxnSpPr>
              <p:spPr>
                <a:xfrm>
                  <a:off x="2095500" y="4078521"/>
                  <a:ext cx="1978209" cy="0"/>
                </a:xfrm>
                <a:prstGeom prst="line">
                  <a:avLst/>
                </a:prstGeom>
                <a:ln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直線コネクタ 48">
                  <a:extLst>
                    <a:ext uri="{FF2B5EF4-FFF2-40B4-BE49-F238E27FC236}">
                      <a16:creationId xmlns:a16="http://schemas.microsoft.com/office/drawing/2014/main" id="{BE81541B-D100-6042-8BC9-A38E44F513E1}"/>
                    </a:ext>
                  </a:extLst>
                </p:cNvPr>
                <p:cNvCxnSpPr/>
                <p:nvPr/>
              </p:nvCxnSpPr>
              <p:spPr>
                <a:xfrm>
                  <a:off x="4073709" y="4076176"/>
                  <a:ext cx="0" cy="10335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直線コネクタ 50">
                  <a:extLst>
                    <a:ext uri="{FF2B5EF4-FFF2-40B4-BE49-F238E27FC236}">
                      <a16:creationId xmlns:a16="http://schemas.microsoft.com/office/drawing/2014/main" id="{A6C1ADA0-0580-794B-B693-7DDA3E5A374C}"/>
                    </a:ext>
                  </a:extLst>
                </p:cNvPr>
                <p:cNvCxnSpPr/>
                <p:nvPr/>
              </p:nvCxnSpPr>
              <p:spPr>
                <a:xfrm>
                  <a:off x="2095500" y="4076176"/>
                  <a:ext cx="0" cy="66952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AE60EE0E-7E69-F04A-B7A9-60FEFD3511F2}"/>
                  </a:ext>
                </a:extLst>
              </p:cNvPr>
              <p:cNvSpPr txBox="1"/>
              <p:nvPr/>
            </p:nvSpPr>
            <p:spPr>
              <a:xfrm>
                <a:off x="2900114" y="3916231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*</a:t>
                </a:r>
                <a:endParaRPr kumimoji="1" lang="ja-JP" altLang="en-US" sz="14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E12335DA-1E01-2542-B411-284B3F444A57}"/>
                </a:ext>
              </a:extLst>
            </p:cNvPr>
            <p:cNvSpPr txBox="1"/>
            <p:nvPr/>
          </p:nvSpPr>
          <p:spPr>
            <a:xfrm>
              <a:off x="901040" y="133856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a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27A170FA-AFAA-C745-AE76-09FD2C3F9004}"/>
                </a:ext>
              </a:extLst>
            </p:cNvPr>
            <p:cNvSpPr txBox="1"/>
            <p:nvPr/>
          </p:nvSpPr>
          <p:spPr>
            <a:xfrm>
              <a:off x="6622792" y="133856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b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1B46491B-1C74-AE48-97D0-C07CF42FEC44}"/>
                </a:ext>
              </a:extLst>
            </p:cNvPr>
            <p:cNvSpPr txBox="1"/>
            <p:nvPr/>
          </p:nvSpPr>
          <p:spPr>
            <a:xfrm>
              <a:off x="901040" y="3639670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c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D63A0DC1-EB42-5443-9BD3-8885D94D4732}"/>
                </a:ext>
              </a:extLst>
            </p:cNvPr>
            <p:cNvSpPr txBox="1"/>
            <p:nvPr/>
          </p:nvSpPr>
          <p:spPr>
            <a:xfrm>
              <a:off x="6622792" y="363967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d</a:t>
              </a:r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9235862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6</TotalTime>
  <Words>39</Words>
  <Application>Microsoft Macintosh PowerPoint</Application>
  <PresentationFormat>ワイド画面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乘 嗣泰</dc:creator>
  <cp:lastModifiedBy>Microsoft Office User</cp:lastModifiedBy>
  <cp:revision>20</cp:revision>
  <cp:lastPrinted>2022-03-18T09:20:19Z</cp:lastPrinted>
  <dcterms:created xsi:type="dcterms:W3CDTF">2022-03-16T14:12:22Z</dcterms:created>
  <dcterms:modified xsi:type="dcterms:W3CDTF">2022-06-06T13:52:29Z</dcterms:modified>
</cp:coreProperties>
</file>